
<file path=[Content_Types].xml><?xml version="1.0" encoding="utf-8"?>
<Types xmlns="http://schemas.openxmlformats.org/package/2006/content-types">
  <Default Extension="bin" ContentType="application/vnd.openxmlformats-officedocument.oleObject"/>
  <Default Extension="wmf" ContentType="image/x-w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08" r:id="rId2"/>
  </p:sldIdLst>
  <p:sldSz cx="6858000" cy="9144000" type="screen4x3"/>
  <p:notesSz cx="6797675" cy="9926638"/>
  <p:defaultTextStyle>
    <a:defPPr>
      <a:defRPr lang="de-DE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 horzBarState="maximized">
    <p:restoredLeft sz="15620"/>
    <p:restoredTop sz="23819" autoAdjust="0"/>
  </p:normalViewPr>
  <p:slideViewPr>
    <p:cSldViewPr>
      <p:cViewPr varScale="1">
        <p:scale>
          <a:sx n="96" d="100"/>
          <a:sy n="96" d="100"/>
        </p:scale>
        <p:origin x="3426" y="10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wmf"/><Relationship Id="rId1" Type="http://schemas.openxmlformats.org/officeDocument/2006/relationships/image" Target="../media/image1.w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038"/>
            <a:ext cx="5829300" cy="1960562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99E0105-BF0F-40B3-B683-A3C47D68F5DA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705967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93D536-A5D0-474F-8063-8095E7B1023D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769568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4972050" y="366713"/>
            <a:ext cx="1543050" cy="780097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342900" y="366713"/>
            <a:ext cx="4476750" cy="780097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AF22FCC-675A-4C1E-8990-5DCCE65F400E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656582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FA6050F-3D25-45A2-BA44-7002FD9A9DB1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32042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338" y="5875338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338" y="3875088"/>
            <a:ext cx="5829300" cy="2000250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64DBFDD-E568-47CB-8462-B50A6D756338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105255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342900" y="213360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505200" y="213360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7BFDCFD-9680-4A72-AA94-F58248DDC79C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177756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046288"/>
            <a:ext cx="3030538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2900363"/>
            <a:ext cx="3030538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4563" y="2046288"/>
            <a:ext cx="3030537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4563" y="2900363"/>
            <a:ext cx="3030537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8CD5C4D-AF1B-40DA-9F1E-64EE647E984D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26236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558213F-EBF2-4334-93B6-D065D65DD777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991659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12B78E5-0B0A-4B80-8282-BF256343F041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632519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3538"/>
            <a:ext cx="2255838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8" y="363538"/>
            <a:ext cx="3833812" cy="7804150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1912938"/>
            <a:ext cx="2255838" cy="62547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BEB0EBB-D016-48D7-8C9E-C589ADD045A0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491591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613" y="6400800"/>
            <a:ext cx="4114800" cy="7556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613" y="81756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de-DE" noProof="0" smtClean="0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613" y="7156450"/>
            <a:ext cx="4114800" cy="10731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E877B85-049B-4BDA-9761-76EBC3210326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567664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de-DE" smtClean="0"/>
              <a:t>Titelmasterformat durch Klicken bearbeiten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342900" y="8326438"/>
            <a:ext cx="1600200" cy="635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50" y="8326438"/>
            <a:ext cx="2171700" cy="635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900" y="8326438"/>
            <a:ext cx="1600200" cy="635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/>
            </a:lvl1pPr>
          </a:lstStyle>
          <a:p>
            <a:pPr>
              <a:defRPr/>
            </a:pPr>
            <a:fld id="{9A62768B-DBE9-457D-842F-457BD079BB6B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w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w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 Box 2"/>
          <p:cNvSpPr txBox="1">
            <a:spLocks noChangeArrowheads="1"/>
          </p:cNvSpPr>
          <p:nvPr/>
        </p:nvSpPr>
        <p:spPr bwMode="auto">
          <a:xfrm>
            <a:off x="-8872" y="-4574"/>
            <a:ext cx="2621230" cy="4001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sz="2000" b="1" dirty="0" smtClean="0"/>
              <a:t>Supporting Figure 7</a:t>
            </a:r>
            <a:endParaRPr lang="en-US" sz="2000" b="1" dirty="0"/>
          </a:p>
        </p:txBody>
      </p:sp>
      <p:sp>
        <p:nvSpPr>
          <p:cNvPr id="3" name="Textfeld 2"/>
          <p:cNvSpPr txBox="1"/>
          <p:nvPr/>
        </p:nvSpPr>
        <p:spPr>
          <a:xfrm>
            <a:off x="3448800" y="683568"/>
            <a:ext cx="27879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DRAQ5-sorted MOLM-13</a:t>
            </a:r>
            <a:endParaRPr lang="en-US" dirty="0"/>
          </a:p>
        </p:txBody>
      </p:sp>
      <p:sp>
        <p:nvSpPr>
          <p:cNvPr id="4" name="Textfeld 3"/>
          <p:cNvSpPr txBox="1"/>
          <p:nvPr/>
        </p:nvSpPr>
        <p:spPr>
          <a:xfrm>
            <a:off x="836712" y="683568"/>
            <a:ext cx="23903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DRAQ5-sorted </a:t>
            </a:r>
            <a:r>
              <a:rPr lang="en-US" dirty="0" err="1" smtClean="0"/>
              <a:t>Jurkat</a:t>
            </a:r>
            <a:endParaRPr lang="en-US" dirty="0"/>
          </a:p>
        </p:txBody>
      </p:sp>
      <p:graphicFrame>
        <p:nvGraphicFramePr>
          <p:cNvPr id="5" name="Objek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70814931"/>
              </p:ext>
            </p:extLst>
          </p:nvPr>
        </p:nvGraphicFramePr>
        <p:xfrm>
          <a:off x="980728" y="1043608"/>
          <a:ext cx="2901950" cy="41529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8332" name="Graph" r:id="rId3" imgW="2901600" imgH="4153680" progId="Origin50.Graph">
                  <p:embed/>
                </p:oleObj>
              </mc:Choice>
              <mc:Fallback>
                <p:oleObj name="Graph" r:id="rId3" imgW="2901600" imgH="4153680" progId="Origin50.Graph">
                  <p:embed/>
                  <p:pic>
                    <p:nvPicPr>
                      <p:cNvPr id="5" name="Objekt 4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980728" y="1043608"/>
                        <a:ext cx="2901950" cy="41529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kt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28737717"/>
              </p:ext>
            </p:extLst>
          </p:nvPr>
        </p:nvGraphicFramePr>
        <p:xfrm>
          <a:off x="3789040" y="1043608"/>
          <a:ext cx="2901950" cy="41529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8333" name="Graph" r:id="rId5" imgW="2901600" imgH="4153680" progId="Origin50.Graph">
                  <p:embed/>
                </p:oleObj>
              </mc:Choice>
              <mc:Fallback>
                <p:oleObj name="Graph" r:id="rId5" imgW="2901600" imgH="4153680" progId="Origin50.Graph">
                  <p:embed/>
                  <p:pic>
                    <p:nvPicPr>
                      <p:cNvPr id="6" name="Objekt 5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789040" y="1043608"/>
                        <a:ext cx="2901950" cy="41529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Textfeld 7"/>
          <p:cNvSpPr txBox="1"/>
          <p:nvPr/>
        </p:nvSpPr>
        <p:spPr>
          <a:xfrm>
            <a:off x="188640" y="3419872"/>
            <a:ext cx="6480720" cy="9387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smtClean="0">
                <a:latin typeface="+mj-lt"/>
              </a:rPr>
              <a:t>Figure S7. </a:t>
            </a:r>
            <a:r>
              <a:rPr lang="en-US" sz="1100" dirty="0"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Autophagy in DRAQ5-sorted cells. Cells were flow-</a:t>
            </a:r>
            <a:r>
              <a:rPr lang="en-US" sz="1100" dirty="0" err="1"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cytometrically</a:t>
            </a:r>
            <a:r>
              <a:rPr lang="en-US" sz="1100" dirty="0"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sorted on the basis of their DRAQ5 fluorescence intensity into G1, S and G2/M phase cells. Autophagy was determined by flow-</a:t>
            </a:r>
            <a:r>
              <a:rPr lang="en-US" sz="1100" dirty="0" err="1"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cytometric</a:t>
            </a:r>
            <a:r>
              <a:rPr lang="en-US" sz="1100" dirty="0"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analysis of </a:t>
            </a:r>
            <a:r>
              <a:rPr lang="en-US" sz="1100" dirty="0" err="1"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Cyto</a:t>
            </a:r>
            <a:r>
              <a:rPr lang="en-US" sz="1100" dirty="0"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-ID-stained cells. </a:t>
            </a:r>
            <a:r>
              <a:rPr lang="en-US" sz="1100" dirty="0" err="1"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Cyto</a:t>
            </a:r>
            <a:r>
              <a:rPr lang="en-US" sz="1100" dirty="0"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-ID fluorescence intensities were normalized to the </a:t>
            </a:r>
            <a:r>
              <a:rPr lang="en-US" sz="1100" dirty="0" err="1"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Cyto</a:t>
            </a:r>
            <a:r>
              <a:rPr lang="en-US" sz="1100" dirty="0"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-ID fluorescence intensities of G1 phase cells. Means ± SEM of each three separate measurements are shown (*</a:t>
            </a:r>
            <a:r>
              <a:rPr lang="en-US" sz="1100" i="1" dirty="0"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P</a:t>
            </a:r>
            <a:r>
              <a:rPr lang="en-US" sz="1100" dirty="0"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&lt; </a:t>
            </a:r>
            <a:r>
              <a:rPr lang="en-US" sz="1100"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0.05</a:t>
            </a:r>
            <a:r>
              <a:rPr lang="en-US" sz="1100" smtClean="0"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).</a:t>
            </a:r>
            <a:endParaRPr lang="en-US" sz="1100" dirty="0" smtClean="0">
              <a:latin typeface="+mj-lt"/>
            </a:endParaRPr>
          </a:p>
        </p:txBody>
      </p:sp>
    </p:spTree>
    <p:extLst>
      <p:ext uri="{BB962C8B-B14F-4D97-AF65-F5344CB8AC3E}">
        <p14:creationId xmlns:p14="http://schemas.microsoft.com/office/powerpoint/2010/main" val="3180770969"/>
      </p:ext>
    </p:extLst>
  </p:cSld>
  <p:clrMapOvr>
    <a:masterClrMapping/>
  </p:clrMapOvr>
</p:sld>
</file>

<file path=ppt/theme/theme1.xml><?xml version="1.0" encoding="utf-8"?>
<a:theme xmlns:a="http://schemas.openxmlformats.org/drawingml/2006/main" name="Standarddesign">
  <a:themeElements>
    <a:clrScheme name="Standarddesign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Standarddesign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Standarddesig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6</Words>
  <Application>Microsoft Office PowerPoint</Application>
  <PresentationFormat>Bildschirmpräsentation (4:3)</PresentationFormat>
  <Paragraphs>4</Paragraphs>
  <Slides>1</Slides>
  <Notes>0</Notes>
  <HiddenSlides>0</HiddenSlides>
  <MMClips>0</MMClips>
  <ScaleCrop>false</ScaleCrop>
  <HeadingPairs>
    <vt:vector size="8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Eingebettete OLE-Server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6" baseType="lpstr">
      <vt:lpstr>Arial</vt:lpstr>
      <vt:lpstr>Calibri</vt:lpstr>
      <vt:lpstr>Times New Roman</vt:lpstr>
      <vt:lpstr>Standarddesign</vt:lpstr>
      <vt:lpstr>Graph</vt:lpstr>
      <vt:lpstr>PowerPoint-Präsentation</vt:lpstr>
    </vt:vector>
  </TitlesOfParts>
  <Company>Universitätsklinikum Jen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olie 1</dc:title>
  <dc:creator>JSonnemann</dc:creator>
  <cp:lastModifiedBy>Sonnemann, Jürgen</cp:lastModifiedBy>
  <cp:revision>1296</cp:revision>
  <cp:lastPrinted>2021-07-21T08:35:57Z</cp:lastPrinted>
  <dcterms:created xsi:type="dcterms:W3CDTF">2013-08-01T14:41:20Z</dcterms:created>
  <dcterms:modified xsi:type="dcterms:W3CDTF">2021-11-19T09:19:50Z</dcterms:modified>
</cp:coreProperties>
</file>